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1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53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3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E16582-9326-4014-BEF6-31F42B811BE5}" type="datetimeFigureOut">
              <a:rPr lang="en-US" smtClean="0"/>
              <a:t>3/10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658C14-38C9-4162-9CE1-6802031CD2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60895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775A7CE-8A7B-B7C3-72B3-ECC37EB29D7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581532C4-F3DA-1998-E6D2-4B5714A54724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FA560CDD-1841-1964-6CFE-987D05BADA2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="1" dirty="0"/>
          </a:p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E4650F-52DC-58A7-36AA-B1CEB0FA78C0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254C10-8DEB-4BDF-B931-790D35DF0D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129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F44788-2FBA-F8F3-14D9-555EAF6A64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4949491-8E01-F579-50BE-C3A19CE91C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81743C-DB1F-2D63-C3F5-18659DE2D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1542B-7012-9E55-C5D5-AA17E97DC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0A06BE-AADF-81B4-8905-02EB9A30D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61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88962-6025-8CC1-7DF7-86CF37A25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7EB2CB-8EF7-94AA-E38E-B12EA24196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4AA7E5-7989-37CA-F7A5-4CC48C201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9DD48-5162-2DA2-45AB-BE0FA9B04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0EA0A3-0829-603C-00E5-C16F69921F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623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DF7339-F575-CD03-E552-031B80E81C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30A21E7-9793-D802-147A-1E3A8842CC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1DCF8C-DB1D-F43C-155D-E2EA3F9F2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E09825-4FAC-F7B1-836A-10A0537F4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24D84F-7BB8-C13A-F80C-2323AA705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680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7FDFD9-B7AF-E9C6-D28A-87B9724579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723FAF-1251-64F3-B898-1A9FD636A7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037A22-9FD8-9B54-AC98-1DA329C8D9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983381-4B16-536C-CE2C-34F03089F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495FC3-1C3F-46C8-EAFA-A4FC850760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325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E7A9D3-10B6-5BCF-148D-43DAE9A869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7138B4-8427-22E5-DBB2-762D84CEAF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7B7EB3-40D0-2780-E422-4BB7A31BF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95A4D1-3579-F870-FBF2-8D3C886F75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F6A27C-1DF5-27F6-595E-F57188BDA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78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8BAC4-C72E-264C-D4CE-FD65848B0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F270A2-E089-B191-F34D-3476D05E00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C8A59A-C6A9-8141-CE56-F7C649589A8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61A93D7-20E8-5FB2-BDE5-D263CB676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CE057A-B6D0-E0D0-FD45-7854D0438F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6944ED-2479-E5B4-359C-A154B851A6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33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5D2272-9F36-DEE6-03ED-5396470AB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B0DCE9-CC6B-54A0-4A1F-BBEB25DF88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25DB41-0B9D-CBE9-A537-58C223A032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5B8797-48C7-37C0-5832-19C38C90AA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9E0014-2BDF-772C-5C37-360403F522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6E0B0D-B5BA-650E-4CC1-06912539A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7C0964-E30E-BA31-2A4B-0916FD959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5550766-0E89-EB5F-AACA-8C6F04497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8520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F878E-311C-8E50-1C37-D18F05CF0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883879-A9FB-62EE-F060-E953A0006D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B12536-4849-3FAB-70C2-3A5896F536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5A67E8-B7EB-A548-3851-F2691EB77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119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A967B5-F6EB-C7DF-AFEA-CECA9D8A7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27CB461-D6C0-7EE2-60E0-A5C32A70EE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5C3E52-92F6-592D-908D-37AE7F7A7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448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4A131-186C-EF7A-BECA-90694556F8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130FD3-139E-F574-77DC-4BB98C4F7E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B9AC07-767A-CF0B-4447-F5586327A1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895FAD-30A2-ECC2-F9A8-0B50727046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30B3C5-25C7-0C06-7B62-61BF651E95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9E95BA-AB81-A8E6-AF56-C955F31FF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520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D1A65-2380-C01D-9B4B-C4A56D99D7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3FB197A-EB1A-E6E3-0D5F-00DBE591E6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39DA3E-7960-3A2E-EE56-D0633BDCC5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FCAD9F-2F86-61B0-F0DE-ED7779A65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8CA728E-C410-0083-503C-36FBCF23D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2D7008-8A0C-AB96-DEB5-1220B1D811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5226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DE14C94-15D0-8613-4111-AC88AFF601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300027-D766-79FE-00FA-A5ED11FD0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7B9F23-B43B-A25F-B905-75D0DB1F9A3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85634D-15B4-4E01-9731-0FE6F742EF9B}" type="datetimeFigureOut">
              <a:rPr lang="en-US" smtClean="0"/>
              <a:t>3/10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6D79A2-F3A5-D35B-175A-87476687A6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F545EA-7605-B835-B550-E939E45670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6A1588-25E2-475B-B378-255FF7EC56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02270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10D6E80-E56B-75E5-0D06-DC18FAAF1F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A5BA4B8-9F7F-91EB-B52A-564960DEEC0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231493"/>
          <a:ext cx="2365375" cy="3468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2364651" imgH="3468644" progId="Prism10.Document">
                  <p:embed/>
                </p:oleObj>
              </mc:Choice>
              <mc:Fallback>
                <p:oleObj name="Prism 10" r:id="rId3" imgW="2364651" imgH="3468644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DA5BA4B8-9F7F-91EB-B52A-564960DEEC0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231493"/>
                        <a:ext cx="2365375" cy="3468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898B7E57-7ACE-7178-EB07-44451FE9022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182440" y="231494"/>
          <a:ext cx="2456720" cy="3468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2273177" imgH="3468644" progId="Prism10.Document">
                  <p:embed/>
                </p:oleObj>
              </mc:Choice>
              <mc:Fallback>
                <p:oleObj name="Prism 10" r:id="rId5" imgW="2273177" imgH="3468644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898B7E57-7ACE-7178-EB07-44451FE9022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82440" y="231494"/>
                        <a:ext cx="2456720" cy="3468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CD9EE339-BD8F-6102-1471-6F05675BA7C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131298" y="115747"/>
          <a:ext cx="2456720" cy="348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2248687" imgH="3468644" progId="Prism10.Document">
                  <p:embed/>
                </p:oleObj>
              </mc:Choice>
              <mc:Fallback>
                <p:oleObj name="Prism 10" r:id="rId7" imgW="2248687" imgH="3468644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CD9EE339-BD8F-6102-1471-6F05675BA7C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31298" y="115747"/>
                        <a:ext cx="2456720" cy="348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4EFC311B-CC55-A407-A331-FA7917672D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42474" y="231494"/>
          <a:ext cx="2456720" cy="348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9" imgW="2385899" imgH="3485976" progId="Prism10.Document">
                  <p:embed/>
                </p:oleObj>
              </mc:Choice>
              <mc:Fallback>
                <p:oleObj name="Prism 10" r:id="rId9" imgW="2385899" imgH="3485976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4EFC311B-CC55-A407-A331-FA7917672D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42474" y="231494"/>
                        <a:ext cx="2456720" cy="348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5AE57F8-CB7E-2A75-C4C0-1C3AAC9D75CB}"/>
              </a:ext>
            </a:extLst>
          </p:cNvPr>
          <p:cNvSpPr txBox="1"/>
          <p:nvPr/>
        </p:nvSpPr>
        <p:spPr>
          <a:xfrm>
            <a:off x="11089863" y="115747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. 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4A64CD4-1AFC-7D85-AC44-A48454226A0F}"/>
              </a:ext>
            </a:extLst>
          </p:cNvPr>
          <p:cNvSpPr txBox="1"/>
          <p:nvPr/>
        </p:nvSpPr>
        <p:spPr>
          <a:xfrm>
            <a:off x="1525676" y="1720322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B5AFEB8-D500-660D-1E13-88A549A9CA16}"/>
              </a:ext>
            </a:extLst>
          </p:cNvPr>
          <p:cNvSpPr txBox="1"/>
          <p:nvPr/>
        </p:nvSpPr>
        <p:spPr>
          <a:xfrm>
            <a:off x="3720236" y="577322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86245F-F1D6-ABEA-0310-72E71C6A815C}"/>
              </a:ext>
            </a:extLst>
          </p:cNvPr>
          <p:cNvSpPr txBox="1"/>
          <p:nvPr/>
        </p:nvSpPr>
        <p:spPr>
          <a:xfrm>
            <a:off x="6318656" y="965942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F132B26-4A2F-217A-6C6F-6C73F0C9AD30}"/>
              </a:ext>
            </a:extLst>
          </p:cNvPr>
          <p:cNvSpPr txBox="1"/>
          <p:nvPr/>
        </p:nvSpPr>
        <p:spPr>
          <a:xfrm>
            <a:off x="8659444" y="688943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AC2A22B-7B1C-1073-6796-B30888E4DFC4}"/>
              </a:ext>
            </a:extLst>
          </p:cNvPr>
          <p:cNvSpPr txBox="1"/>
          <p:nvPr/>
        </p:nvSpPr>
        <p:spPr>
          <a:xfrm>
            <a:off x="3893521" y="4273377"/>
            <a:ext cx="739971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.S1. Effect of avasimibe treatment on mRNA expression of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YP450 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mily genes, drug efflux (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R1I2/ PXR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, and multi-drug resistance gene (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CC1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in mammary glands of SV40 C3 </a:t>
            </a:r>
            <a:r>
              <a:rPr lang="en-US" sz="1400" b="1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g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ce.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xpression of indicated mRNAs in mammary glands of SV40C3TAg mice by qPCR. The Y axis depicts the fold changes in average gene expression that was calculated  by using the </a:t>
            </a:r>
            <a:r>
              <a:rPr lang="en-US" sz="14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ΔΔCt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ethod after normalizing with ribosomal protein </a:t>
            </a:r>
            <a:r>
              <a:rPr lang="en-US" sz="14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19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 The lack of change at the mRNA level does not exclude the possibility that avasimibe may affect the activity of CYP enzymes and ABCC1 activity.  </a:t>
            </a:r>
          </a:p>
          <a:p>
            <a:endParaRPr lang="en-US" sz="1400" dirty="0"/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2C59D69B-3F5F-8BBB-8D60-EC709BA8A86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9231794" y="115747"/>
          <a:ext cx="2468940" cy="3486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1" imgW="2247247" imgH="3485976" progId="Prism10.Document">
                  <p:embed/>
                </p:oleObj>
              </mc:Choice>
              <mc:Fallback>
                <p:oleObj name="Prism 10" r:id="rId11" imgW="2247247" imgH="3485976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2C59D69B-3F5F-8BBB-8D60-EC709BA8A8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231794" y="115747"/>
                        <a:ext cx="2468940" cy="3486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600113BD-45F1-16C1-8F9C-1A37E26E441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98769" y="3427677"/>
          <a:ext cx="2341563" cy="3522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3" imgW="2341602" imgH="3523387" progId="Prism10.Document">
                  <p:embed/>
                </p:oleObj>
              </mc:Choice>
              <mc:Fallback>
                <p:oleObj name="Prism 10" r:id="rId13" imgW="2341602" imgH="3523387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00113BD-45F1-16C1-8F9C-1A37E26E441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98769" y="3427677"/>
                        <a:ext cx="2341563" cy="3522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38698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3</Words>
  <Application>Microsoft Macintosh PowerPoint</Application>
  <PresentationFormat>Widescreen</PresentationFormat>
  <Paragraphs>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Office Theme</vt:lpstr>
      <vt:lpstr>Prism 10</vt:lpstr>
      <vt:lpstr>PowerPoint Presentation</vt:lpstr>
    </vt:vector>
  </TitlesOfParts>
  <Company>M.D. Anderson Cancer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hardwaj,Anjana</dc:creator>
  <cp:lastModifiedBy>Bhardwaj,Anjana</cp:lastModifiedBy>
  <cp:revision>3</cp:revision>
  <dcterms:created xsi:type="dcterms:W3CDTF">2025-02-28T16:19:24Z</dcterms:created>
  <dcterms:modified xsi:type="dcterms:W3CDTF">2025-03-10T21:36:11Z</dcterms:modified>
</cp:coreProperties>
</file>